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296"/>
  </p:normalViewPr>
  <p:slideViewPr>
    <p:cSldViewPr snapToGrid="0">
      <p:cViewPr varScale="1">
        <p:scale>
          <a:sx n="116" d="100"/>
          <a:sy n="116" d="100"/>
        </p:scale>
        <p:origin x="118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115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619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039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376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117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004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721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6124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119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464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867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C20F87-AC35-F241-AE2E-37147BFA04B6}" type="datetimeFigureOut">
              <a:rPr lang="en-US" smtClean="0"/>
              <a:t>9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4E833-D5F1-C84C-AA69-C2091E763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327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2319107D-FD24-E70D-D3D2-29401C1071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366" y="59374"/>
            <a:ext cx="9779401" cy="6782927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4B9D1AF4-53A1-884B-0A06-9FAF50FF7E89}"/>
              </a:ext>
            </a:extLst>
          </p:cNvPr>
          <p:cNvSpPr txBox="1"/>
          <p:nvPr/>
        </p:nvSpPr>
        <p:spPr>
          <a:xfrm>
            <a:off x="2558006" y="6472969"/>
            <a:ext cx="50234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lang="en-US" sz="9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aplan-Meyer curves for survival by dialysis-dependency. (A) Progression-free and (B) overall survival of patients under hemodialysis and patients not on hemodialysis.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1848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30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ypoldt, Lisa B.</dc:creator>
  <cp:lastModifiedBy>MDPI</cp:lastModifiedBy>
  <cp:revision>2</cp:revision>
  <dcterms:created xsi:type="dcterms:W3CDTF">2023-02-10T15:03:39Z</dcterms:created>
  <dcterms:modified xsi:type="dcterms:W3CDTF">2023-09-21T03:59:56Z</dcterms:modified>
</cp:coreProperties>
</file>